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8" r:id="rId2"/>
  </p:sldIdLst>
  <p:sldSz cx="7099300" cy="99425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2"/>
    <p:restoredTop sz="94701"/>
  </p:normalViewPr>
  <p:slideViewPr>
    <p:cSldViewPr snapToGrid="0">
      <p:cViewPr varScale="1">
        <p:scale>
          <a:sx n="83" d="100"/>
          <a:sy n="83" d="100"/>
        </p:scale>
        <p:origin x="355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9BC07-D09E-824B-B552-05E2E99B71CC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B73340-D26C-414E-BE20-46968DC4C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483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2448" y="1627167"/>
            <a:ext cx="6034405" cy="3461467"/>
          </a:xfrm>
        </p:spPr>
        <p:txBody>
          <a:bodyPr anchor="b"/>
          <a:lstStyle>
            <a:lvl1pPr algn="ctr"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7413" y="5222121"/>
            <a:ext cx="5324475" cy="2400472"/>
          </a:xfrm>
        </p:spPr>
        <p:txBody>
          <a:bodyPr/>
          <a:lstStyle>
            <a:lvl1pPr marL="0" indent="0" algn="ctr">
              <a:buNone/>
              <a:defRPr sz="1863"/>
            </a:lvl1pPr>
            <a:lvl2pPr marL="354970" indent="0" algn="ctr">
              <a:buNone/>
              <a:defRPr sz="1553"/>
            </a:lvl2pPr>
            <a:lvl3pPr marL="709940" indent="0" algn="ctr">
              <a:buNone/>
              <a:defRPr sz="1398"/>
            </a:lvl3pPr>
            <a:lvl4pPr marL="1064910" indent="0" algn="ctr">
              <a:buNone/>
              <a:defRPr sz="1242"/>
            </a:lvl4pPr>
            <a:lvl5pPr marL="1419880" indent="0" algn="ctr">
              <a:buNone/>
              <a:defRPr sz="1242"/>
            </a:lvl5pPr>
            <a:lvl6pPr marL="1774850" indent="0" algn="ctr">
              <a:buNone/>
              <a:defRPr sz="1242"/>
            </a:lvl6pPr>
            <a:lvl7pPr marL="2129820" indent="0" algn="ctr">
              <a:buNone/>
              <a:defRPr sz="1242"/>
            </a:lvl7pPr>
            <a:lvl8pPr marL="2484791" indent="0" algn="ctr">
              <a:buNone/>
              <a:defRPr sz="1242"/>
            </a:lvl8pPr>
            <a:lvl9pPr marL="2839761" indent="0" algn="ctr">
              <a:buNone/>
              <a:defRPr sz="1242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552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20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80437" y="529347"/>
            <a:ext cx="1530787" cy="8425820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077" y="529347"/>
            <a:ext cx="4503618" cy="8425820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255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480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80" y="2478726"/>
            <a:ext cx="6123146" cy="4135809"/>
          </a:xfrm>
        </p:spPr>
        <p:txBody>
          <a:bodyPr anchor="b"/>
          <a:lstStyle>
            <a:lvl1pPr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80" y="6653661"/>
            <a:ext cx="6123146" cy="2174924"/>
          </a:xfrm>
        </p:spPr>
        <p:txBody>
          <a:bodyPr/>
          <a:lstStyle>
            <a:lvl1pPr marL="0" indent="0">
              <a:buNone/>
              <a:defRPr sz="1863">
                <a:solidFill>
                  <a:schemeClr val="tx1">
                    <a:tint val="82000"/>
                  </a:schemeClr>
                </a:solidFill>
              </a:defRPr>
            </a:lvl1pPr>
            <a:lvl2pPr marL="354970" indent="0">
              <a:buNone/>
              <a:defRPr sz="1553">
                <a:solidFill>
                  <a:schemeClr val="tx1">
                    <a:tint val="82000"/>
                  </a:schemeClr>
                </a:solidFill>
              </a:defRPr>
            </a:lvl2pPr>
            <a:lvl3pPr marL="709940" indent="0">
              <a:buNone/>
              <a:defRPr sz="1398">
                <a:solidFill>
                  <a:schemeClr val="tx1">
                    <a:tint val="82000"/>
                  </a:schemeClr>
                </a:solidFill>
              </a:defRPr>
            </a:lvl3pPr>
            <a:lvl4pPr marL="106491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4pPr>
            <a:lvl5pPr marL="141988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5pPr>
            <a:lvl6pPr marL="177485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6pPr>
            <a:lvl7pPr marL="212982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7pPr>
            <a:lvl8pPr marL="248479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8pPr>
            <a:lvl9pPr marL="283976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631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077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4020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44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529349"/>
            <a:ext cx="6123146" cy="192176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002" y="2437297"/>
            <a:ext cx="3003336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002" y="3631779"/>
            <a:ext cx="3003336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94021" y="2437297"/>
            <a:ext cx="3018127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94021" y="3631779"/>
            <a:ext cx="3018127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264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38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411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8127" y="1431540"/>
            <a:ext cx="3594021" cy="7065628"/>
          </a:xfrm>
        </p:spPr>
        <p:txBody>
          <a:bodyPr/>
          <a:lstStyle>
            <a:lvl1pPr>
              <a:defRPr sz="2484"/>
            </a:lvl1pPr>
            <a:lvl2pPr>
              <a:defRPr sz="2174"/>
            </a:lvl2pPr>
            <a:lvl3pPr>
              <a:defRPr sz="1863"/>
            </a:lvl3pPr>
            <a:lvl4pPr>
              <a:defRPr sz="1553"/>
            </a:lvl4pPr>
            <a:lvl5pPr>
              <a:defRPr sz="1553"/>
            </a:lvl5pPr>
            <a:lvl6pPr>
              <a:defRPr sz="1553"/>
            </a:lvl6pPr>
            <a:lvl7pPr>
              <a:defRPr sz="1553"/>
            </a:lvl7pPr>
            <a:lvl8pPr>
              <a:defRPr sz="1553"/>
            </a:lvl8pPr>
            <a:lvl9pPr>
              <a:defRPr sz="15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415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18127" y="1431540"/>
            <a:ext cx="3594021" cy="7065628"/>
          </a:xfrm>
        </p:spPr>
        <p:txBody>
          <a:bodyPr anchor="t"/>
          <a:lstStyle>
            <a:lvl1pPr marL="0" indent="0">
              <a:buNone/>
              <a:defRPr sz="2484"/>
            </a:lvl1pPr>
            <a:lvl2pPr marL="354970" indent="0">
              <a:buNone/>
              <a:defRPr sz="2174"/>
            </a:lvl2pPr>
            <a:lvl3pPr marL="709940" indent="0">
              <a:buNone/>
              <a:defRPr sz="1863"/>
            </a:lvl3pPr>
            <a:lvl4pPr marL="1064910" indent="0">
              <a:buNone/>
              <a:defRPr sz="1553"/>
            </a:lvl4pPr>
            <a:lvl5pPr marL="1419880" indent="0">
              <a:buNone/>
              <a:defRPr sz="1553"/>
            </a:lvl5pPr>
            <a:lvl6pPr marL="1774850" indent="0">
              <a:buNone/>
              <a:defRPr sz="1553"/>
            </a:lvl6pPr>
            <a:lvl7pPr marL="2129820" indent="0">
              <a:buNone/>
              <a:defRPr sz="1553"/>
            </a:lvl7pPr>
            <a:lvl8pPr marL="2484791" indent="0">
              <a:buNone/>
              <a:defRPr sz="1553"/>
            </a:lvl8pPr>
            <a:lvl9pPr marL="2839761" indent="0">
              <a:buNone/>
              <a:defRPr sz="15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773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077" y="529349"/>
            <a:ext cx="6123146" cy="19217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077" y="2646734"/>
            <a:ext cx="6123146" cy="63084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077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51643" y="9215239"/>
            <a:ext cx="2396014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13880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390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09940" rtl="0" eaLnBrk="1" latinLnBrk="0" hangingPunct="1">
        <a:lnSpc>
          <a:spcPct val="90000"/>
        </a:lnSpc>
        <a:spcBef>
          <a:spcPct val="0"/>
        </a:spcBef>
        <a:buNone/>
        <a:defRPr sz="34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7485" indent="-177485" algn="l" defTabSz="709940" rtl="0" eaLnBrk="1" latinLnBrk="0" hangingPunct="1">
        <a:lnSpc>
          <a:spcPct val="90000"/>
        </a:lnSpc>
        <a:spcBef>
          <a:spcPts val="776"/>
        </a:spcBef>
        <a:buFont typeface="Arial" panose="020B0604020202020204" pitchFamily="34" charset="0"/>
        <a:buChar char="•"/>
        <a:defRPr sz="2174" kern="1200">
          <a:solidFill>
            <a:schemeClr val="tx1"/>
          </a:solidFill>
          <a:latin typeface="+mn-lt"/>
          <a:ea typeface="+mn-ea"/>
          <a:cs typeface="+mn-cs"/>
        </a:defRPr>
      </a:lvl1pPr>
      <a:lvl2pPr marL="53245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2pPr>
      <a:lvl3pPr marL="88742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553" kern="1200">
          <a:solidFill>
            <a:schemeClr val="tx1"/>
          </a:solidFill>
          <a:latin typeface="+mn-lt"/>
          <a:ea typeface="+mn-ea"/>
          <a:cs typeface="+mn-cs"/>
        </a:defRPr>
      </a:lvl3pPr>
      <a:lvl4pPr marL="124239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59736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95233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30730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66227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301724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1pPr>
      <a:lvl2pPr marL="35497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2pPr>
      <a:lvl3pPr marL="70994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3pPr>
      <a:lvl4pPr marL="106491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41988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77485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12982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48479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283976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57CEDA8F-59A3-0CAD-F8C0-E67306B1B3FC}"/>
              </a:ext>
            </a:extLst>
          </p:cNvPr>
          <p:cNvGrpSpPr/>
          <p:nvPr/>
        </p:nvGrpSpPr>
        <p:grpSpPr>
          <a:xfrm>
            <a:off x="720166" y="2082800"/>
            <a:ext cx="5092698" cy="6800850"/>
            <a:chOff x="567766" y="800100"/>
            <a:chExt cx="5092698" cy="6800850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82163877-5B78-AE81-12A8-99E267374F43}"/>
                </a:ext>
              </a:extLst>
            </p:cNvPr>
            <p:cNvGrpSpPr/>
            <p:nvPr/>
          </p:nvGrpSpPr>
          <p:grpSpPr>
            <a:xfrm>
              <a:off x="567766" y="800100"/>
              <a:ext cx="5045634" cy="2266950"/>
              <a:chOff x="567766" y="800100"/>
              <a:chExt cx="5045634" cy="2266950"/>
            </a:xfrm>
          </p:grpSpPr>
          <p:pic>
            <p:nvPicPr>
              <p:cNvPr id="1027" name="Picture 3" descr="A graph of a number of dots&#10;&#10;Description automatically generated with medium confidence">
                <a:extLst>
                  <a:ext uri="{FF2B5EF4-FFF2-40B4-BE49-F238E27FC236}">
                    <a16:creationId xmlns:a16="http://schemas.microsoft.com/office/drawing/2014/main" id="{57D36AAA-F620-9538-DDB4-9E5F15D2629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19200" y="869950"/>
                <a:ext cx="4394200" cy="21971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" name="Rectangle 4">
                <a:extLst>
                  <a:ext uri="{FF2B5EF4-FFF2-40B4-BE49-F238E27FC236}">
                    <a16:creationId xmlns:a16="http://schemas.microsoft.com/office/drawing/2014/main" id="{EE41BF23-AF4D-68AF-B413-F78340D615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7766" y="800100"/>
                <a:ext cx="2199641" cy="55399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non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</a:t>
                </a: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                      Model I (p=0.017)</a:t>
                </a:r>
                <a:endParaRPr kumimoji="0" lang="en-US" altLang="en-US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CDD617E1-B56A-0439-BE7D-96F90BBA83ED}"/>
                </a:ext>
              </a:extLst>
            </p:cNvPr>
            <p:cNvGrpSpPr/>
            <p:nvPr/>
          </p:nvGrpSpPr>
          <p:grpSpPr>
            <a:xfrm>
              <a:off x="567766" y="3136900"/>
              <a:ext cx="5045634" cy="2311400"/>
              <a:chOff x="567766" y="3136900"/>
              <a:chExt cx="5045634" cy="2311400"/>
            </a:xfrm>
          </p:grpSpPr>
          <p:pic>
            <p:nvPicPr>
              <p:cNvPr id="1026" name="Picture 2" descr="A graph of a number of dots&#10;&#10;Description automatically generated with medium confidence">
                <a:extLst>
                  <a:ext uri="{FF2B5EF4-FFF2-40B4-BE49-F238E27FC236}">
                    <a16:creationId xmlns:a16="http://schemas.microsoft.com/office/drawing/2014/main" id="{7C4EEFDE-FA62-4E88-D75E-32655F64611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06500" y="3136900"/>
                <a:ext cx="4406900" cy="23114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" name="Rectangle 5">
                <a:extLst>
                  <a:ext uri="{FF2B5EF4-FFF2-40B4-BE49-F238E27FC236}">
                    <a16:creationId xmlns:a16="http://schemas.microsoft.com/office/drawing/2014/main" id="{FA9F51EF-3FDA-CD71-6A4B-E93F6A0D78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7766" y="3152269"/>
                <a:ext cx="2238113" cy="55399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non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B</a:t>
                </a: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                      Model II (p=0.109)</a:t>
                </a:r>
                <a:endParaRPr kumimoji="0" lang="en-US" altLang="en-US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44726A4-9EF6-16EA-A8F0-95E7734EA612}"/>
                </a:ext>
              </a:extLst>
            </p:cNvPr>
            <p:cNvGrpSpPr/>
            <p:nvPr/>
          </p:nvGrpSpPr>
          <p:grpSpPr>
            <a:xfrm>
              <a:off x="567766" y="5518150"/>
              <a:ext cx="5092698" cy="2082800"/>
              <a:chOff x="609602" y="5848350"/>
              <a:chExt cx="5092698" cy="2082800"/>
            </a:xfrm>
          </p:grpSpPr>
          <p:pic>
            <p:nvPicPr>
              <p:cNvPr id="1025" name="Picture 1" descr="A graph of a line&#10;&#10;Description automatically generated with medium confidence">
                <a:extLst>
                  <a:ext uri="{FF2B5EF4-FFF2-40B4-BE49-F238E27FC236}">
                    <a16:creationId xmlns:a16="http://schemas.microsoft.com/office/drawing/2014/main" id="{066F3CD9-2095-10EC-C631-111CD2284B2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06500" y="5848350"/>
                <a:ext cx="4495800" cy="20828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" name="Rectangle 6">
                <a:extLst>
                  <a:ext uri="{FF2B5EF4-FFF2-40B4-BE49-F238E27FC236}">
                    <a16:creationId xmlns:a16="http://schemas.microsoft.com/office/drawing/2014/main" id="{B99B9F5C-3116-4393-4C8D-AB845420FF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9602" y="5903818"/>
                <a:ext cx="2271776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non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</a:t>
                </a: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                      Model III (p=0.001)</a:t>
                </a:r>
                <a:endParaRPr kumimoji="0" lang="en-US" altLang="en-US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CB09B396-1489-07E5-05FB-0AE641D40EE5}"/>
              </a:ext>
            </a:extLst>
          </p:cNvPr>
          <p:cNvSpPr txBox="1"/>
          <p:nvPr/>
        </p:nvSpPr>
        <p:spPr>
          <a:xfrm>
            <a:off x="109537" y="231045"/>
            <a:ext cx="691832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Scaled Schoenfeld residuals for corresponding fixed-effect models, inclusive of study as a categorical variable, relating to mixed-effects survival models in Table 2.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el I compares </a:t>
            </a:r>
            <a:r>
              <a:rPr lang="en-GB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F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lasses across all patients irrespective of additional Ras mutation;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el II compares Class 1 without Ras vs Class 3 with Ras mutations;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.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odel III examines additional Ras mutation status within Class 3. P-values represent significance of violation of proportional hazards assumptions.</a:t>
            </a:r>
            <a:r>
              <a:rPr lang="en-GB" sz="1200" dirty="0">
                <a:effectLst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41341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supplementary_figure_1" id="{7C626575-2EA4-F944-A432-58960AD0DE46}" vid="{83430D31-096D-FF42-AA65-42DAA4213C38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8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nnor Woolley</dc:creator>
  <cp:lastModifiedBy>Connor Woolley</cp:lastModifiedBy>
  <cp:revision>2</cp:revision>
  <dcterms:created xsi:type="dcterms:W3CDTF">2024-11-13T18:28:31Z</dcterms:created>
  <dcterms:modified xsi:type="dcterms:W3CDTF">2024-11-13T18:29:29Z</dcterms:modified>
</cp:coreProperties>
</file>